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AD93E-A719-49B5-AC92-BBF4AD55F1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F73DB-673D-420B-AD4B-D186A210C5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C39A4-6802-4E80-BC14-4084E26489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4CE84-9D91-4FEC-9D05-174A76AA4A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84702-9D7C-4A8F-8AE8-DEA5421E70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2CD2B-B88A-4DC4-BB55-840EE8ED1F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51870-FE87-4FA6-8740-19111DDAEE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B45F2-D66F-488F-AF90-DE599C5657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5841B-F1FB-42AE-8E3A-560608DE31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E6E42-793F-423A-A5C7-679ED60B87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49D02-6D8A-4DE1-94A2-E7C848FDAF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7656B-A8CF-4AFA-8AAC-16F4A2A3E3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63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636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63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DA9A69-3829-4DD6-8440-1D8D0226E89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1600200"/>
            <a:ext cx="1905120" cy="1752480"/>
            <a:chOff x="0" y="1600200"/>
            <a:chExt cx="1905120" cy="17524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75600" y="1600200"/>
              <a:ext cx="1829520" cy="1752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"/>
            <p:cNvGrpSpPr/>
            <p:nvPr/>
          </p:nvGrpSpPr>
          <p:grpSpPr>
            <a:xfrm>
              <a:off x="0" y="1600200"/>
              <a:ext cx="670320" cy="370800"/>
              <a:chOff x="0" y="1600200"/>
              <a:chExt cx="670320" cy="370800"/>
            </a:xfrm>
          </p:grpSpPr>
          <p:grpSp>
            <p:nvGrpSpPr>
              <p:cNvPr id="44" name=""/>
              <p:cNvGrpSpPr/>
              <p:nvPr/>
            </p:nvGrpSpPr>
            <p:grpSpPr>
              <a:xfrm>
                <a:off x="0" y="1637280"/>
                <a:ext cx="575640" cy="301320"/>
                <a:chOff x="0" y="1637280"/>
                <a:chExt cx="575640" cy="30132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162720" y="1706760"/>
                  <a:ext cx="16272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0" y="1637280"/>
                  <a:ext cx="575640" cy="301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7" name=""/>
              <p:cNvSpPr/>
              <p:nvPr/>
            </p:nvSpPr>
            <p:spPr>
              <a:xfrm>
                <a:off x="22320" y="1600200"/>
                <a:ext cx="648000" cy="37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48" name=""/>
          <p:cNvGrpSpPr/>
          <p:nvPr/>
        </p:nvGrpSpPr>
        <p:grpSpPr>
          <a:xfrm>
            <a:off x="1905120" y="1600200"/>
            <a:ext cx="1828440" cy="1752120"/>
            <a:chOff x="1905120" y="1600200"/>
            <a:chExt cx="1828440" cy="1752120"/>
          </a:xfrm>
        </p:grpSpPr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1977480" y="1609200"/>
              <a:ext cx="1756080" cy="1743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0" name=""/>
            <p:cNvGrpSpPr/>
            <p:nvPr/>
          </p:nvGrpSpPr>
          <p:grpSpPr>
            <a:xfrm>
              <a:off x="1905120" y="1600200"/>
              <a:ext cx="644040" cy="369000"/>
              <a:chOff x="1905120" y="1600200"/>
              <a:chExt cx="644040" cy="369000"/>
            </a:xfrm>
          </p:grpSpPr>
          <p:grpSp>
            <p:nvGrpSpPr>
              <p:cNvPr id="51" name=""/>
              <p:cNvGrpSpPr/>
              <p:nvPr/>
            </p:nvGrpSpPr>
            <p:grpSpPr>
              <a:xfrm>
                <a:off x="1905120" y="1636920"/>
                <a:ext cx="552600" cy="299880"/>
                <a:chOff x="1905120" y="1636920"/>
                <a:chExt cx="552600" cy="299880"/>
              </a:xfrm>
            </p:grpSpPr>
            <p:sp>
              <p:nvSpPr>
                <p:cNvPr id="52" name=""/>
                <p:cNvSpPr/>
                <p:nvPr/>
              </p:nvSpPr>
              <p:spPr>
                <a:xfrm>
                  <a:off x="2061360" y="1706040"/>
                  <a:ext cx="15624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1905120" y="1636920"/>
                  <a:ext cx="552600" cy="299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" name=""/>
              <p:cNvSpPr/>
              <p:nvPr/>
            </p:nvSpPr>
            <p:spPr>
              <a:xfrm>
                <a:off x="1926720" y="1600200"/>
                <a:ext cx="622440" cy="36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5" name=""/>
          <p:cNvGrpSpPr/>
          <p:nvPr/>
        </p:nvGrpSpPr>
        <p:grpSpPr>
          <a:xfrm>
            <a:off x="3733920" y="1600200"/>
            <a:ext cx="1676160" cy="1752480"/>
            <a:chOff x="3733920" y="1600200"/>
            <a:chExt cx="1676160" cy="1752480"/>
          </a:xfrm>
        </p:grpSpPr>
        <p:pic>
          <p:nvPicPr>
            <p:cNvPr id="56" name="" descr=""/>
            <p:cNvPicPr/>
            <p:nvPr/>
          </p:nvPicPr>
          <p:blipFill>
            <a:blip r:embed="rId3"/>
            <a:stretch/>
          </p:blipFill>
          <p:spPr>
            <a:xfrm>
              <a:off x="3808800" y="1618560"/>
              <a:ext cx="1601280" cy="173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7" name=""/>
            <p:cNvGrpSpPr/>
            <p:nvPr/>
          </p:nvGrpSpPr>
          <p:grpSpPr>
            <a:xfrm>
              <a:off x="3733920" y="1600200"/>
              <a:ext cx="587160" cy="366840"/>
              <a:chOff x="3733920" y="1600200"/>
              <a:chExt cx="587160" cy="366840"/>
            </a:xfrm>
          </p:grpSpPr>
          <p:grpSp>
            <p:nvGrpSpPr>
              <p:cNvPr id="58" name=""/>
              <p:cNvGrpSpPr/>
              <p:nvPr/>
            </p:nvGrpSpPr>
            <p:grpSpPr>
              <a:xfrm>
                <a:off x="3733920" y="1636920"/>
                <a:ext cx="504000" cy="298080"/>
                <a:chOff x="3733920" y="1636920"/>
                <a:chExt cx="504000" cy="298080"/>
              </a:xfrm>
            </p:grpSpPr>
            <p:sp>
              <p:nvSpPr>
                <p:cNvPr id="59" name=""/>
                <p:cNvSpPr/>
                <p:nvPr/>
              </p:nvSpPr>
              <p:spPr>
                <a:xfrm>
                  <a:off x="3876480" y="1705680"/>
                  <a:ext cx="14256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3733920" y="1636920"/>
                  <a:ext cx="504000" cy="298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1" name=""/>
              <p:cNvSpPr/>
              <p:nvPr/>
            </p:nvSpPr>
            <p:spPr>
              <a:xfrm>
                <a:off x="3753720" y="1600200"/>
                <a:ext cx="567360" cy="36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2" name=""/>
          <p:cNvGrpSpPr/>
          <p:nvPr/>
        </p:nvGrpSpPr>
        <p:grpSpPr>
          <a:xfrm>
            <a:off x="5410080" y="1600200"/>
            <a:ext cx="1752840" cy="1752480"/>
            <a:chOff x="5410080" y="1600200"/>
            <a:chExt cx="1752840" cy="1752480"/>
          </a:xfrm>
        </p:grpSpPr>
        <p:pic>
          <p:nvPicPr>
            <p:cNvPr id="63" name="" descr=""/>
            <p:cNvPicPr/>
            <p:nvPr/>
          </p:nvPicPr>
          <p:blipFill>
            <a:blip r:embed="rId4"/>
            <a:stretch/>
          </p:blipFill>
          <p:spPr>
            <a:xfrm>
              <a:off x="5479920" y="1618560"/>
              <a:ext cx="1683000" cy="173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4" name=""/>
            <p:cNvGrpSpPr/>
            <p:nvPr/>
          </p:nvGrpSpPr>
          <p:grpSpPr>
            <a:xfrm>
              <a:off x="5410080" y="1600200"/>
              <a:ext cx="617040" cy="366840"/>
              <a:chOff x="5410080" y="1600200"/>
              <a:chExt cx="617040" cy="366840"/>
            </a:xfrm>
          </p:grpSpPr>
          <p:grpSp>
            <p:nvGrpSpPr>
              <p:cNvPr id="65" name=""/>
              <p:cNvGrpSpPr/>
              <p:nvPr/>
            </p:nvGrpSpPr>
            <p:grpSpPr>
              <a:xfrm>
                <a:off x="5410080" y="1636920"/>
                <a:ext cx="529920" cy="298080"/>
                <a:chOff x="5410080" y="1636920"/>
                <a:chExt cx="529920" cy="298080"/>
              </a:xfrm>
            </p:grpSpPr>
            <p:sp>
              <p:nvSpPr>
                <p:cNvPr id="66" name=""/>
                <p:cNvSpPr/>
                <p:nvPr/>
              </p:nvSpPr>
              <p:spPr>
                <a:xfrm>
                  <a:off x="5559840" y="1705680"/>
                  <a:ext cx="14976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5410080" y="1636920"/>
                  <a:ext cx="529920" cy="298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8" name=""/>
              <p:cNvSpPr/>
              <p:nvPr/>
            </p:nvSpPr>
            <p:spPr>
              <a:xfrm>
                <a:off x="5430600" y="1600200"/>
                <a:ext cx="596520" cy="36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9" name=""/>
          <p:cNvGrpSpPr/>
          <p:nvPr/>
        </p:nvGrpSpPr>
        <p:grpSpPr>
          <a:xfrm>
            <a:off x="7162920" y="1600200"/>
            <a:ext cx="1752480" cy="1752480"/>
            <a:chOff x="7162920" y="1600200"/>
            <a:chExt cx="1752480" cy="1752480"/>
          </a:xfrm>
        </p:grpSpPr>
        <p:pic>
          <p:nvPicPr>
            <p:cNvPr id="70" name="" descr=""/>
            <p:cNvPicPr/>
            <p:nvPr/>
          </p:nvPicPr>
          <p:blipFill>
            <a:blip r:embed="rId5"/>
            <a:stretch/>
          </p:blipFill>
          <p:spPr>
            <a:xfrm>
              <a:off x="7232400" y="1600200"/>
              <a:ext cx="1683000" cy="1752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1" name=""/>
            <p:cNvGrpSpPr/>
            <p:nvPr/>
          </p:nvGrpSpPr>
          <p:grpSpPr>
            <a:xfrm>
              <a:off x="7162920" y="1600200"/>
              <a:ext cx="616680" cy="370800"/>
              <a:chOff x="7162920" y="1600200"/>
              <a:chExt cx="616680" cy="370800"/>
            </a:xfrm>
          </p:grpSpPr>
          <p:grpSp>
            <p:nvGrpSpPr>
              <p:cNvPr id="72" name=""/>
              <p:cNvGrpSpPr/>
              <p:nvPr/>
            </p:nvGrpSpPr>
            <p:grpSpPr>
              <a:xfrm>
                <a:off x="7162920" y="1637280"/>
                <a:ext cx="529560" cy="301320"/>
                <a:chOff x="7162920" y="1637280"/>
                <a:chExt cx="529560" cy="301320"/>
              </a:xfrm>
            </p:grpSpPr>
            <p:sp>
              <p:nvSpPr>
                <p:cNvPr id="73" name=""/>
                <p:cNvSpPr/>
                <p:nvPr/>
              </p:nvSpPr>
              <p:spPr>
                <a:xfrm>
                  <a:off x="7312680" y="1706760"/>
                  <a:ext cx="14976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7162920" y="1637280"/>
                  <a:ext cx="529560" cy="301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5" name=""/>
              <p:cNvSpPr/>
              <p:nvPr/>
            </p:nvSpPr>
            <p:spPr>
              <a:xfrm>
                <a:off x="7183440" y="1600200"/>
                <a:ext cx="596160" cy="37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6" name=""/>
          <p:cNvSpPr/>
          <p:nvPr/>
        </p:nvSpPr>
        <p:spPr>
          <a:xfrm>
            <a:off x="457200" y="12952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D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438280" y="12952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D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657600" y="126360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3/CD4 Overl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562720" y="126360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Topograph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934320" y="1066680"/>
            <a:ext cx="2209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3/CD4/Topo overl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" name=""/>
          <p:cNvGrpSpPr/>
          <p:nvPr/>
        </p:nvGrpSpPr>
        <p:grpSpPr>
          <a:xfrm>
            <a:off x="0" y="4343400"/>
            <a:ext cx="1905120" cy="1752120"/>
            <a:chOff x="0" y="4343400"/>
            <a:chExt cx="1905120" cy="1752120"/>
          </a:xfrm>
        </p:grpSpPr>
        <p:pic>
          <p:nvPicPr>
            <p:cNvPr id="82" name="" descr=""/>
            <p:cNvPicPr/>
            <p:nvPr/>
          </p:nvPicPr>
          <p:blipFill>
            <a:blip r:embed="rId6"/>
            <a:stretch/>
          </p:blipFill>
          <p:spPr>
            <a:xfrm>
              <a:off x="75600" y="4352400"/>
              <a:ext cx="1829520" cy="1743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3" name=""/>
            <p:cNvGrpSpPr/>
            <p:nvPr/>
          </p:nvGrpSpPr>
          <p:grpSpPr>
            <a:xfrm>
              <a:off x="0" y="4343400"/>
              <a:ext cx="671040" cy="369000"/>
              <a:chOff x="0" y="4343400"/>
              <a:chExt cx="671040" cy="369000"/>
            </a:xfrm>
          </p:grpSpPr>
          <p:grpSp>
            <p:nvGrpSpPr>
              <p:cNvPr id="84" name=""/>
              <p:cNvGrpSpPr/>
              <p:nvPr/>
            </p:nvGrpSpPr>
            <p:grpSpPr>
              <a:xfrm>
                <a:off x="0" y="4380120"/>
                <a:ext cx="576000" cy="299880"/>
                <a:chOff x="0" y="4380120"/>
                <a:chExt cx="576000" cy="299880"/>
              </a:xfrm>
            </p:grpSpPr>
            <p:sp>
              <p:nvSpPr>
                <p:cNvPr id="85" name=""/>
                <p:cNvSpPr/>
                <p:nvPr/>
              </p:nvSpPr>
              <p:spPr>
                <a:xfrm>
                  <a:off x="162720" y="4449240"/>
                  <a:ext cx="16272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0" y="4380120"/>
                  <a:ext cx="576000" cy="299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7" name=""/>
              <p:cNvSpPr/>
              <p:nvPr/>
            </p:nvSpPr>
            <p:spPr>
              <a:xfrm>
                <a:off x="22680" y="4343400"/>
                <a:ext cx="648360" cy="36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88" name=""/>
          <p:cNvGrpSpPr/>
          <p:nvPr/>
        </p:nvGrpSpPr>
        <p:grpSpPr>
          <a:xfrm>
            <a:off x="1905120" y="4343400"/>
            <a:ext cx="1828440" cy="1752480"/>
            <a:chOff x="1905120" y="4343400"/>
            <a:chExt cx="1828440" cy="1752480"/>
          </a:xfrm>
        </p:grpSpPr>
        <p:pic>
          <p:nvPicPr>
            <p:cNvPr id="89" name="" descr=""/>
            <p:cNvPicPr/>
            <p:nvPr/>
          </p:nvPicPr>
          <p:blipFill>
            <a:blip r:embed="rId7"/>
            <a:stretch/>
          </p:blipFill>
          <p:spPr>
            <a:xfrm>
              <a:off x="1995480" y="4343400"/>
              <a:ext cx="1738080" cy="1752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0" name=""/>
            <p:cNvGrpSpPr/>
            <p:nvPr/>
          </p:nvGrpSpPr>
          <p:grpSpPr>
            <a:xfrm>
              <a:off x="1905120" y="4343400"/>
              <a:ext cx="637200" cy="370800"/>
              <a:chOff x="1905120" y="4343400"/>
              <a:chExt cx="637200" cy="370800"/>
            </a:xfrm>
          </p:grpSpPr>
          <p:grpSp>
            <p:nvGrpSpPr>
              <p:cNvPr id="91" name=""/>
              <p:cNvGrpSpPr/>
              <p:nvPr/>
            </p:nvGrpSpPr>
            <p:grpSpPr>
              <a:xfrm>
                <a:off x="1905120" y="4380480"/>
                <a:ext cx="547200" cy="301320"/>
                <a:chOff x="1905120" y="4380480"/>
                <a:chExt cx="547200" cy="301320"/>
              </a:xfrm>
            </p:grpSpPr>
            <p:sp>
              <p:nvSpPr>
                <p:cNvPr id="92" name=""/>
                <p:cNvSpPr/>
                <p:nvPr/>
              </p:nvSpPr>
              <p:spPr>
                <a:xfrm>
                  <a:off x="2059920" y="4449960"/>
                  <a:ext cx="15480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1905120" y="4380480"/>
                  <a:ext cx="547200" cy="301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4" name=""/>
              <p:cNvSpPr/>
              <p:nvPr/>
            </p:nvSpPr>
            <p:spPr>
              <a:xfrm>
                <a:off x="1926360" y="4343400"/>
                <a:ext cx="615960" cy="37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5" name=""/>
          <p:cNvGrpSpPr/>
          <p:nvPr/>
        </p:nvGrpSpPr>
        <p:grpSpPr>
          <a:xfrm>
            <a:off x="3733920" y="4343400"/>
            <a:ext cx="1796760" cy="1752120"/>
            <a:chOff x="3733920" y="4343400"/>
            <a:chExt cx="1796760" cy="1752120"/>
          </a:xfrm>
        </p:grpSpPr>
        <p:pic>
          <p:nvPicPr>
            <p:cNvPr id="96" name="" descr=""/>
            <p:cNvPicPr/>
            <p:nvPr/>
          </p:nvPicPr>
          <p:blipFill>
            <a:blip r:embed="rId8"/>
            <a:stretch/>
          </p:blipFill>
          <p:spPr>
            <a:xfrm>
              <a:off x="3796560" y="4352400"/>
              <a:ext cx="1734120" cy="1743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7" name=""/>
            <p:cNvGrpSpPr/>
            <p:nvPr/>
          </p:nvGrpSpPr>
          <p:grpSpPr>
            <a:xfrm>
              <a:off x="3733920" y="4343400"/>
              <a:ext cx="635760" cy="369000"/>
              <a:chOff x="3733920" y="4343400"/>
              <a:chExt cx="635760" cy="369000"/>
            </a:xfrm>
          </p:grpSpPr>
          <p:grpSp>
            <p:nvGrpSpPr>
              <p:cNvPr id="98" name=""/>
              <p:cNvGrpSpPr/>
              <p:nvPr/>
            </p:nvGrpSpPr>
            <p:grpSpPr>
              <a:xfrm>
                <a:off x="3733920" y="4380120"/>
                <a:ext cx="546120" cy="299880"/>
                <a:chOff x="3733920" y="4380120"/>
                <a:chExt cx="546120" cy="299880"/>
              </a:xfrm>
            </p:grpSpPr>
            <p:sp>
              <p:nvSpPr>
                <p:cNvPr id="99" name=""/>
                <p:cNvSpPr/>
                <p:nvPr/>
              </p:nvSpPr>
              <p:spPr>
                <a:xfrm>
                  <a:off x="3888360" y="4449240"/>
                  <a:ext cx="15444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3733920" y="4380120"/>
                  <a:ext cx="546120" cy="299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1" name=""/>
              <p:cNvSpPr/>
              <p:nvPr/>
            </p:nvSpPr>
            <p:spPr>
              <a:xfrm>
                <a:off x="3755160" y="4343400"/>
                <a:ext cx="614520" cy="36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2" name=""/>
          <p:cNvGrpSpPr/>
          <p:nvPr/>
        </p:nvGrpSpPr>
        <p:grpSpPr>
          <a:xfrm>
            <a:off x="5486400" y="4343400"/>
            <a:ext cx="1828800" cy="1752120"/>
            <a:chOff x="5486400" y="4343400"/>
            <a:chExt cx="1828800" cy="1752120"/>
          </a:xfrm>
        </p:grpSpPr>
        <p:pic>
          <p:nvPicPr>
            <p:cNvPr id="103" name="" descr=""/>
            <p:cNvPicPr/>
            <p:nvPr/>
          </p:nvPicPr>
          <p:blipFill>
            <a:blip r:embed="rId9"/>
            <a:stretch/>
          </p:blipFill>
          <p:spPr>
            <a:xfrm>
              <a:off x="5576760" y="4352400"/>
              <a:ext cx="1738440" cy="1743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4" name=""/>
            <p:cNvGrpSpPr/>
            <p:nvPr/>
          </p:nvGrpSpPr>
          <p:grpSpPr>
            <a:xfrm>
              <a:off x="5486400" y="4343400"/>
              <a:ext cx="637200" cy="368640"/>
              <a:chOff x="5486400" y="4343400"/>
              <a:chExt cx="637200" cy="368640"/>
            </a:xfrm>
          </p:grpSpPr>
          <p:grpSp>
            <p:nvGrpSpPr>
              <p:cNvPr id="105" name=""/>
              <p:cNvGrpSpPr/>
              <p:nvPr/>
            </p:nvGrpSpPr>
            <p:grpSpPr>
              <a:xfrm>
                <a:off x="5486400" y="4380120"/>
                <a:ext cx="547200" cy="299520"/>
                <a:chOff x="5486400" y="4380120"/>
                <a:chExt cx="547200" cy="299520"/>
              </a:xfrm>
            </p:grpSpPr>
            <p:sp>
              <p:nvSpPr>
                <p:cNvPr id="106" name=""/>
                <p:cNvSpPr/>
                <p:nvPr/>
              </p:nvSpPr>
              <p:spPr>
                <a:xfrm>
                  <a:off x="5641200" y="4449240"/>
                  <a:ext cx="15480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5486400" y="4380120"/>
                  <a:ext cx="547200" cy="299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8" name=""/>
              <p:cNvSpPr/>
              <p:nvPr/>
            </p:nvSpPr>
            <p:spPr>
              <a:xfrm>
                <a:off x="5507640" y="4343400"/>
                <a:ext cx="615960" cy="368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9" name=""/>
          <p:cNvGrpSpPr/>
          <p:nvPr/>
        </p:nvGrpSpPr>
        <p:grpSpPr>
          <a:xfrm>
            <a:off x="7315200" y="4343400"/>
            <a:ext cx="1676160" cy="1752480"/>
            <a:chOff x="7315200" y="4343400"/>
            <a:chExt cx="1676160" cy="1752480"/>
          </a:xfrm>
        </p:grpSpPr>
        <p:pic>
          <p:nvPicPr>
            <p:cNvPr id="110" name="" descr=""/>
            <p:cNvPicPr/>
            <p:nvPr/>
          </p:nvPicPr>
          <p:blipFill>
            <a:blip r:embed="rId10"/>
            <a:stretch/>
          </p:blipFill>
          <p:spPr>
            <a:xfrm>
              <a:off x="7385760" y="4361760"/>
              <a:ext cx="1605600" cy="173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1" name=""/>
            <p:cNvGrpSpPr/>
            <p:nvPr/>
          </p:nvGrpSpPr>
          <p:grpSpPr>
            <a:xfrm>
              <a:off x="7315200" y="4343400"/>
              <a:ext cx="588960" cy="366840"/>
              <a:chOff x="7315200" y="4343400"/>
              <a:chExt cx="588960" cy="366840"/>
            </a:xfrm>
          </p:grpSpPr>
          <p:grpSp>
            <p:nvGrpSpPr>
              <p:cNvPr id="112" name=""/>
              <p:cNvGrpSpPr/>
              <p:nvPr/>
            </p:nvGrpSpPr>
            <p:grpSpPr>
              <a:xfrm>
                <a:off x="7315200" y="4380120"/>
                <a:ext cx="505440" cy="298080"/>
                <a:chOff x="7315200" y="4380120"/>
                <a:chExt cx="505440" cy="298080"/>
              </a:xfrm>
            </p:grpSpPr>
            <p:sp>
              <p:nvSpPr>
                <p:cNvPr id="113" name=""/>
                <p:cNvSpPr/>
                <p:nvPr/>
              </p:nvSpPr>
              <p:spPr>
                <a:xfrm>
                  <a:off x="7458120" y="4448880"/>
                  <a:ext cx="14292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7315200" y="4380120"/>
                  <a:ext cx="505440" cy="298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5" name=""/>
              <p:cNvSpPr/>
              <p:nvPr/>
            </p:nvSpPr>
            <p:spPr>
              <a:xfrm>
                <a:off x="7335000" y="4343400"/>
                <a:ext cx="569160" cy="36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16" name=""/>
          <p:cNvSpPr/>
          <p:nvPr/>
        </p:nvSpPr>
        <p:spPr>
          <a:xfrm>
            <a:off x="457200" y="40528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D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438280" y="40528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D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657600" y="402120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3/CD8 Overl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562720" y="402120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Topograph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7010280" y="3824280"/>
            <a:ext cx="2210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3/CD8/Topo overl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76320" y="90360"/>
            <a:ext cx="99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0" y="8524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0" y="35956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09T07:01:16Z</dcterms:created>
  <dc:creator>UIer</dc:creator>
  <dc:description/>
  <dc:language>en-US</dc:language>
  <cp:lastModifiedBy>UIer</cp:lastModifiedBy>
  <dcterms:modified xsi:type="dcterms:W3CDTF">2009-05-09T21:59:39Z</dcterms:modified>
  <cp:revision>10</cp:revision>
  <dc:subject/>
  <dc:title>幻灯片 1</dc:title>
</cp:coreProperties>
</file>